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9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04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85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2819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844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23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780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1397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179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7006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8161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2332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436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261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E4EF8B-8D35-47C1-943E-5CC903EEC020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0CC42D-CF48-4D81-BA70-C78ECEB6F6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8234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0" r:id="rId1"/>
    <p:sldLayoutId id="2147483721" r:id="rId2"/>
    <p:sldLayoutId id="2147483722" r:id="rId3"/>
    <p:sldLayoutId id="2147483723" r:id="rId4"/>
    <p:sldLayoutId id="2147483724" r:id="rId5"/>
    <p:sldLayoutId id="2147483725" r:id="rId6"/>
    <p:sldLayoutId id="2147483726" r:id="rId7"/>
    <p:sldLayoutId id="2147483727" r:id="rId8"/>
    <p:sldLayoutId id="2147483728" r:id="rId9"/>
    <p:sldLayoutId id="2147483729" r:id="rId10"/>
    <p:sldLayoutId id="2147483730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2"/>
          <a:srcRect l="2454" t="1637" r="1518" b="3285"/>
          <a:stretch/>
        </p:blipFill>
        <p:spPr>
          <a:xfrm>
            <a:off x="1845601" y="1753470"/>
            <a:ext cx="4099484" cy="2972787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 rotWithShape="1">
          <a:blip r:embed="rId3"/>
          <a:srcRect l="2237" t="1807" r="1519" b="3285"/>
          <a:stretch/>
        </p:blipFill>
        <p:spPr>
          <a:xfrm>
            <a:off x="6254847" y="1753470"/>
            <a:ext cx="4111894" cy="296977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BB7E3BF-5B2A-1EAC-6B25-AFD77559E5AB}"/>
              </a:ext>
            </a:extLst>
          </p:cNvPr>
          <p:cNvSpPr txBox="1"/>
          <p:nvPr/>
        </p:nvSpPr>
        <p:spPr>
          <a:xfrm>
            <a:off x="4780884" y="6125368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upplementary Figure 1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2753B16-FE49-16B9-BC62-B0E134F72B7C}"/>
              </a:ext>
            </a:extLst>
          </p:cNvPr>
          <p:cNvSpPr txBox="1"/>
          <p:nvPr/>
        </p:nvSpPr>
        <p:spPr>
          <a:xfrm>
            <a:off x="2904936" y="1334051"/>
            <a:ext cx="2191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     CKD stages 1</a:t>
            </a:r>
            <a:r>
              <a:rPr kumimoji="1" lang="en-US" altLang="ja-JP" sz="1800" b="1" i="0" u="none" strike="noStrike" kern="105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–3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CCFA9FB-9ED5-EAE1-CB28-27D7698E78A1}"/>
              </a:ext>
            </a:extLst>
          </p:cNvPr>
          <p:cNvSpPr txBox="1"/>
          <p:nvPr/>
        </p:nvSpPr>
        <p:spPr>
          <a:xfrm>
            <a:off x="7261872" y="1334051"/>
            <a:ext cx="2191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B</a:t>
            </a:r>
            <a:r>
              <a:rPr lang="ja-JP" altLang="en-US" b="1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    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KD stages 4</a:t>
            </a:r>
            <a:r>
              <a:rPr kumimoji="1" lang="en-US" altLang="ja-JP" sz="1800" b="1" i="0" u="none" strike="noStrike" kern="105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–5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8D3F805-5DC7-7C87-1B10-7B994E410F3A}"/>
              </a:ext>
            </a:extLst>
          </p:cNvPr>
          <p:cNvSpPr txBox="1"/>
          <p:nvPr/>
        </p:nvSpPr>
        <p:spPr>
          <a:xfrm>
            <a:off x="3534677" y="539526"/>
            <a:ext cx="5071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ROC analysis of BNP as a predictor of CV events 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8E38267-7995-3A2F-18E3-F331F03F6B2E}"/>
              </a:ext>
            </a:extLst>
          </p:cNvPr>
          <p:cNvSpPr txBox="1"/>
          <p:nvPr/>
        </p:nvSpPr>
        <p:spPr>
          <a:xfrm rot="16200000">
            <a:off x="1115211" y="2870907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ensitivity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2B7585B-7372-5F52-342E-19C7CBBCB96E}"/>
              </a:ext>
            </a:extLst>
          </p:cNvPr>
          <p:cNvSpPr txBox="1"/>
          <p:nvPr/>
        </p:nvSpPr>
        <p:spPr>
          <a:xfrm flipH="1">
            <a:off x="3230102" y="4603424"/>
            <a:ext cx="1744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-Specificity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53F8501-4CFF-B6E4-434A-D4F172BE17B2}"/>
              </a:ext>
            </a:extLst>
          </p:cNvPr>
          <p:cNvSpPr txBox="1"/>
          <p:nvPr/>
        </p:nvSpPr>
        <p:spPr>
          <a:xfrm>
            <a:off x="3644034" y="3476201"/>
            <a:ext cx="23455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UC =  0.709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95%CI: 0.646, 0.771)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005C100-C49B-E4EA-222E-E8A92A3186B7}"/>
              </a:ext>
            </a:extLst>
          </p:cNvPr>
          <p:cNvSpPr txBox="1"/>
          <p:nvPr/>
        </p:nvSpPr>
        <p:spPr>
          <a:xfrm>
            <a:off x="8072725" y="3476201"/>
            <a:ext cx="23455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UC =  0.637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95%CI: 0.572, 0.701)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C1A6725-6FEC-FF9D-C2D0-4E273C7FCA58}"/>
              </a:ext>
            </a:extLst>
          </p:cNvPr>
          <p:cNvSpPr txBox="1"/>
          <p:nvPr/>
        </p:nvSpPr>
        <p:spPr>
          <a:xfrm rot="16200000">
            <a:off x="5464886" y="287107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ensitivity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BE481EA-6952-AAC6-4208-D401C7188BAD}"/>
              </a:ext>
            </a:extLst>
          </p:cNvPr>
          <p:cNvSpPr txBox="1"/>
          <p:nvPr/>
        </p:nvSpPr>
        <p:spPr>
          <a:xfrm flipH="1">
            <a:off x="7671858" y="4603587"/>
            <a:ext cx="1744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-Specificity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D6590D7-63F4-1236-832F-E0797A8A69AD}"/>
              </a:ext>
            </a:extLst>
          </p:cNvPr>
          <p:cNvSpPr txBox="1"/>
          <p:nvPr/>
        </p:nvSpPr>
        <p:spPr>
          <a:xfrm>
            <a:off x="1773757" y="5202038"/>
            <a:ext cx="86444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ROC, receiver operating characteristic; BNP, B-type natriuretic peptide; CV, cardiovascular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KD, chronic kidney disease; AUC, area under curve; CI, confidence interval.</a:t>
            </a:r>
          </a:p>
        </p:txBody>
      </p:sp>
    </p:spTree>
    <p:extLst>
      <p:ext uri="{BB962C8B-B14F-4D97-AF65-F5344CB8AC3E}">
        <p14:creationId xmlns:p14="http://schemas.microsoft.com/office/powerpoint/2010/main" val="108156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Words>81</Words>
  <Application>Microsoft Office PowerPoint</Application>
  <PresentationFormat>ワイド画面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yama</dc:creator>
  <cp:lastModifiedBy>腎臓内科 九州医療</cp:lastModifiedBy>
  <cp:revision>7</cp:revision>
  <dcterms:created xsi:type="dcterms:W3CDTF">2024-05-13T12:37:39Z</dcterms:created>
  <dcterms:modified xsi:type="dcterms:W3CDTF">2024-05-15T01:46:51Z</dcterms:modified>
</cp:coreProperties>
</file>